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3" r:id="rId5"/>
    <p:sldId id="264" r:id="rId6"/>
    <p:sldId id="265" r:id="rId7"/>
    <p:sldId id="266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6" d="100"/>
          <a:sy n="96" d="100"/>
        </p:scale>
        <p:origin x="86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yn Massic" userId="c0e81cb0-6dd5-47c3-a30b-334e33ec1179" providerId="ADAL" clId="{88B595A1-F96E-4F1A-BFB4-89A963AFDAAA}"/>
    <pc:docChg chg="delSld modSld">
      <pc:chgData name="Lauryn Massic" userId="c0e81cb0-6dd5-47c3-a30b-334e33ec1179" providerId="ADAL" clId="{88B595A1-F96E-4F1A-BFB4-89A963AFDAAA}" dt="2025-03-10T16:03:10.105" v="10" actId="20577"/>
      <pc:docMkLst>
        <pc:docMk/>
      </pc:docMkLst>
      <pc:sldChg chg="del">
        <pc:chgData name="Lauryn Massic" userId="c0e81cb0-6dd5-47c3-a30b-334e33ec1179" providerId="ADAL" clId="{88B595A1-F96E-4F1A-BFB4-89A963AFDAAA}" dt="2025-03-10T16:02:54.097" v="0" actId="2696"/>
        <pc:sldMkLst>
          <pc:docMk/>
          <pc:sldMk cId="1022712737" sldId="256"/>
        </pc:sldMkLst>
      </pc:sldChg>
      <pc:sldChg chg="del">
        <pc:chgData name="Lauryn Massic" userId="c0e81cb0-6dd5-47c3-a30b-334e33ec1179" providerId="ADAL" clId="{88B595A1-F96E-4F1A-BFB4-89A963AFDAAA}" dt="2025-03-10T16:02:54.601" v="1" actId="2696"/>
        <pc:sldMkLst>
          <pc:docMk/>
          <pc:sldMk cId="2415867105" sldId="257"/>
        </pc:sldMkLst>
      </pc:sldChg>
      <pc:sldChg chg="del">
        <pc:chgData name="Lauryn Massic" userId="c0e81cb0-6dd5-47c3-a30b-334e33ec1179" providerId="ADAL" clId="{88B595A1-F96E-4F1A-BFB4-89A963AFDAAA}" dt="2025-03-10T16:02:55.047" v="2" actId="2696"/>
        <pc:sldMkLst>
          <pc:docMk/>
          <pc:sldMk cId="472150915" sldId="258"/>
        </pc:sldMkLst>
      </pc:sldChg>
      <pc:sldChg chg="del">
        <pc:chgData name="Lauryn Massic" userId="c0e81cb0-6dd5-47c3-a30b-334e33ec1179" providerId="ADAL" clId="{88B595A1-F96E-4F1A-BFB4-89A963AFDAAA}" dt="2025-03-10T16:02:56.869" v="5" actId="2696"/>
        <pc:sldMkLst>
          <pc:docMk/>
          <pc:sldMk cId="324659390" sldId="259"/>
        </pc:sldMkLst>
      </pc:sldChg>
      <pc:sldChg chg="del">
        <pc:chgData name="Lauryn Massic" userId="c0e81cb0-6dd5-47c3-a30b-334e33ec1179" providerId="ADAL" clId="{88B595A1-F96E-4F1A-BFB4-89A963AFDAAA}" dt="2025-03-10T16:02:55.587" v="3" actId="2696"/>
        <pc:sldMkLst>
          <pc:docMk/>
          <pc:sldMk cId="1099259097" sldId="260"/>
        </pc:sldMkLst>
      </pc:sldChg>
      <pc:sldChg chg="del">
        <pc:chgData name="Lauryn Massic" userId="c0e81cb0-6dd5-47c3-a30b-334e33ec1179" providerId="ADAL" clId="{88B595A1-F96E-4F1A-BFB4-89A963AFDAAA}" dt="2025-03-10T16:02:56.325" v="4" actId="2696"/>
        <pc:sldMkLst>
          <pc:docMk/>
          <pc:sldMk cId="1483095365" sldId="261"/>
        </pc:sldMkLst>
      </pc:sldChg>
      <pc:sldChg chg="del">
        <pc:chgData name="Lauryn Massic" userId="c0e81cb0-6dd5-47c3-a30b-334e33ec1179" providerId="ADAL" clId="{88B595A1-F96E-4F1A-BFB4-89A963AFDAAA}" dt="2025-03-10T16:02:57.665" v="6" actId="2696"/>
        <pc:sldMkLst>
          <pc:docMk/>
          <pc:sldMk cId="2637789779" sldId="262"/>
        </pc:sldMkLst>
      </pc:sldChg>
      <pc:sldChg chg="modSp">
        <pc:chgData name="Lauryn Massic" userId="c0e81cb0-6dd5-47c3-a30b-334e33ec1179" providerId="ADAL" clId="{88B595A1-F96E-4F1A-BFB4-89A963AFDAAA}" dt="2025-03-10T16:03:10.105" v="10" actId="20577"/>
        <pc:sldMkLst>
          <pc:docMk/>
          <pc:sldMk cId="656038181" sldId="266"/>
        </pc:sldMkLst>
        <pc:spChg chg="mod">
          <ac:chgData name="Lauryn Massic" userId="c0e81cb0-6dd5-47c3-a30b-334e33ec1179" providerId="ADAL" clId="{88B595A1-F96E-4F1A-BFB4-89A963AFDAAA}" dt="2025-03-10T16:03:10.105" v="10" actId="20577"/>
          <ac:spMkLst>
            <pc:docMk/>
            <pc:sldMk cId="656038181" sldId="266"/>
            <ac:spMk id="4" creationId="{B6EA6AFA-1E0A-4D79-AC97-8C27996D9550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4F6E8F-CFD8-42F2-8FB2-01B95DA3EA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2C05DA-8CA4-4336-B158-815821D95E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1B563A-E113-46D4-8982-B79FA5FB6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F74E6-51FE-4778-A101-261864D76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263C22-401A-47A7-BBF7-C3D78A889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2466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E17207-A89A-4D16-943B-9DF0FB2B90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C0360B-9A79-4CC1-B39F-8FEDD3CD48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349999-3912-44D3-801B-DA91A8DBD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503F67-9FD6-45CC-B9F0-542F3260B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67F4B5-F522-4EB0-8361-51EA5C6E3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4908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D2BDA0-159D-408F-8D00-53B1829BB7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742204-7562-4249-B02F-55B26FA15C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F2F7E6-41E4-4B81-A443-D61CF3F87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2F820A-B4E6-44F2-AEB3-93B357543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4C1AB3-696C-492A-9290-C872756A4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191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9759E-83EA-40EE-A0C1-0261A8F94F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4E5338-30C5-47BB-B2C9-96760D3DA7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1257E6-53F1-48F9-A25B-59E8652B1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ABEFB3-3B54-4C52-967C-1EEDA8F58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7F7FFE-F3CB-44BB-B9B5-5022B6CB4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002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6C8E97-7434-404E-A78D-E3DFECB25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F57C6B-69D6-4607-ADE6-C20DC15E54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48CA73-8DDF-4B2C-9580-E34EBAD4D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D7C62D-F436-4D4E-82ED-1078CBFCB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7A78DC-872E-4E92-B5E4-2D23E5149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3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D1EBC0-1D96-4309-B173-C72CA4686F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6AB69C-AE54-4ADD-9760-EF1E7E25A7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1774C1-9AB0-4A54-B192-11ECB50E82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91BDF5-DBC6-4372-A50F-D88E9AEB5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974711-411C-457B-8288-3D5FEC1D8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6E642C-3B54-4791-963A-8A0C2E909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696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13C55B-F544-45B3-8CD7-9798A73CE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0E38CA-9510-4477-876A-B7808F6DEE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FF7F9F-F5FE-4E5A-99B1-2DAED2838A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24C9E2-8D7F-4FCA-9E78-0D0A03EBF1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2989E7-C5B0-4D2D-842E-5ED4122D14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8A74CA-74EC-4C53-A2AC-9559AA3E7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28FB31-DAFA-4FD7-AFA3-BAF9F9790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1892085-BFAB-455F-9CA7-A0198E9C9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445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E22BA9-3678-4BAF-88AF-8FFDDE522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49DF272-DF70-49F2-BAE5-8529780E0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3A755D-BDAB-402C-864A-D72771B67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779321-7CF0-439E-B8C6-1BB28EBCE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872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38AB4E-C3B0-4E48-A9C4-DA4B63C26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240E74-7887-4FF8-BC68-EC4D35ADE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C656F6-7B3A-435F-8F26-DBE30CB2A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887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04C052-F287-4941-A21E-812669AB1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289B45-6634-4250-BFD4-473EFDEC84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6766E4-EBF2-4AE6-BB25-8D8CE3B0AB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77D986-D7E9-426A-97F1-F243F0040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3AE9DC-0166-4121-BAC5-CE2641CBF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629F51-A45D-4CF2-BCE0-103900830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080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FB99B9-EBD5-41C8-B075-90D0B26158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BE09043-B16E-47A3-9D77-4AD77EE825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4FEFAC-7CE0-42D2-9F82-7FF8E3D161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003395-6AE4-4FEB-9092-B5D38D0F5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D0F071-DCCB-4927-8E76-12444C796A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FC240F-36F1-4201-BD29-4E2244831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291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4332C6-C9CF-4385-AE83-A175852D6C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01B3E5-ED92-4CE1-81C5-B3AA417C28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887312-3653-452A-A734-0AB6E442D9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483B4-9F64-4A49-8363-0E9F7A3A34C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8D1065-65A6-4058-8621-CDA523D022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448322-F545-4150-9907-59A181F86C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FB227-02CB-4050-8570-94E429E94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38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8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emf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8A6A1F-F9B1-40C9-8A89-7D2A2AB7AB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 1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4828D3-72D6-4C22-8465-1F0839BEF1F0}"/>
              </a:ext>
            </a:extLst>
          </p:cNvPr>
          <p:cNvSpPr/>
          <p:nvPr/>
        </p:nvSpPr>
        <p:spPr>
          <a:xfrm>
            <a:off x="980661" y="2643482"/>
            <a:ext cx="3432312" cy="25512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: End of Ergosterol Biosynthesis Pathway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ameshift/nonsense mutations in LNV002 are highlighted in underlined. Sterols that compose LNV002 are red. The legend defines what enzyme the ERG genes code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F4EA7A3D-9B3C-DB79-F9AA-A343D4037698}"/>
              </a:ext>
            </a:extLst>
          </p:cNvPr>
          <p:cNvGrpSpPr/>
          <p:nvPr/>
        </p:nvGrpSpPr>
        <p:grpSpPr>
          <a:xfrm>
            <a:off x="5820920" y="700087"/>
            <a:ext cx="5897562" cy="5792788"/>
            <a:chOff x="2027238" y="403225"/>
            <a:chExt cx="5897562" cy="5792788"/>
          </a:xfrm>
        </p:grpSpPr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9A995F1B-DA08-DE46-6C28-B9DFA67C99BF}"/>
                </a:ext>
              </a:extLst>
            </p:cNvPr>
            <p:cNvCxnSpPr/>
            <p:nvPr/>
          </p:nvCxnSpPr>
          <p:spPr bwMode="auto">
            <a:xfrm>
              <a:off x="5183188" y="3570288"/>
              <a:ext cx="519112" cy="158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55438E7C-20AF-19EE-391B-D9EF11446CF2}"/>
                </a:ext>
              </a:extLst>
            </p:cNvPr>
            <p:cNvGrpSpPr/>
            <p:nvPr/>
          </p:nvGrpSpPr>
          <p:grpSpPr>
            <a:xfrm>
              <a:off x="2027238" y="403225"/>
              <a:ext cx="5897562" cy="5792788"/>
              <a:chOff x="2027238" y="403225"/>
              <a:chExt cx="5897562" cy="5792788"/>
            </a:xfrm>
          </p:grpSpPr>
          <p:cxnSp>
            <p:nvCxnSpPr>
              <p:cNvPr id="8" name="Straight Arrow Connector 7">
                <a:extLst>
                  <a:ext uri="{FF2B5EF4-FFF2-40B4-BE49-F238E27FC236}">
                    <a16:creationId xmlns:a16="http://schemas.microsoft.com/office/drawing/2014/main" id="{790675C5-2A86-4D85-1CCA-1E478CA03E12}"/>
                  </a:ext>
                </a:extLst>
              </p:cNvPr>
              <p:cNvCxnSpPr/>
              <p:nvPr/>
            </p:nvCxnSpPr>
            <p:spPr bwMode="auto">
              <a:xfrm flipH="1">
                <a:off x="2628900" y="1576388"/>
                <a:ext cx="0" cy="5635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85DB85A7-E44C-B80F-8759-DFF4041AAEF0}"/>
                  </a:ext>
                </a:extLst>
              </p:cNvPr>
              <p:cNvGrpSpPr/>
              <p:nvPr/>
            </p:nvGrpSpPr>
            <p:grpSpPr>
              <a:xfrm>
                <a:off x="2027238" y="403225"/>
                <a:ext cx="5897562" cy="5792788"/>
                <a:chOff x="2027238" y="403225"/>
                <a:chExt cx="5897562" cy="5792788"/>
              </a:xfrm>
            </p:grpSpPr>
            <p:cxnSp>
              <p:nvCxnSpPr>
                <p:cNvPr id="10" name="Straight Arrow Connector 9">
                  <a:extLst>
                    <a:ext uri="{FF2B5EF4-FFF2-40B4-BE49-F238E27FC236}">
                      <a16:creationId xmlns:a16="http://schemas.microsoft.com/office/drawing/2014/main" id="{DC571180-59B0-AF0F-65F8-771AF1089B3E}"/>
                    </a:ext>
                  </a:extLst>
                </p:cNvPr>
                <p:cNvCxnSpPr/>
                <p:nvPr/>
              </p:nvCxnSpPr>
              <p:spPr bwMode="auto">
                <a:xfrm flipH="1">
                  <a:off x="2592388" y="2706688"/>
                  <a:ext cx="0" cy="563562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B91A26AE-563B-04AE-E296-3529C852F5C5}"/>
                    </a:ext>
                  </a:extLst>
                </p:cNvPr>
                <p:cNvGrpSpPr/>
                <p:nvPr/>
              </p:nvGrpSpPr>
              <p:grpSpPr>
                <a:xfrm>
                  <a:off x="2027238" y="403225"/>
                  <a:ext cx="5897562" cy="5792788"/>
                  <a:chOff x="2027238" y="403225"/>
                  <a:chExt cx="5897562" cy="5792788"/>
                </a:xfrm>
              </p:grpSpPr>
              <p:cxnSp>
                <p:nvCxnSpPr>
                  <p:cNvPr id="12" name="Straight Arrow Connector 11">
                    <a:extLst>
                      <a:ext uri="{FF2B5EF4-FFF2-40B4-BE49-F238E27FC236}">
                        <a16:creationId xmlns:a16="http://schemas.microsoft.com/office/drawing/2014/main" id="{C3E46E7F-A3F4-7427-B5F4-AFD7868582FB}"/>
                      </a:ext>
                    </a:extLst>
                  </p:cNvPr>
                  <p:cNvCxnSpPr/>
                  <p:nvPr/>
                </p:nvCxnSpPr>
                <p:spPr bwMode="auto">
                  <a:xfrm flipH="1">
                    <a:off x="2592388" y="3873500"/>
                    <a:ext cx="0" cy="563563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3" name="Group 12">
                    <a:extLst>
                      <a:ext uri="{FF2B5EF4-FFF2-40B4-BE49-F238E27FC236}">
                        <a16:creationId xmlns:a16="http://schemas.microsoft.com/office/drawing/2014/main" id="{9DFF96C0-A176-07E1-CA9C-13F2251FF656}"/>
                      </a:ext>
                    </a:extLst>
                  </p:cNvPr>
                  <p:cNvGrpSpPr/>
                  <p:nvPr/>
                </p:nvGrpSpPr>
                <p:grpSpPr>
                  <a:xfrm>
                    <a:off x="2027238" y="403225"/>
                    <a:ext cx="5897562" cy="5792788"/>
                    <a:chOff x="2027238" y="403225"/>
                    <a:chExt cx="5897562" cy="5792788"/>
                  </a:xfrm>
                </p:grpSpPr>
                <p:sp>
                  <p:nvSpPr>
                    <p:cNvPr id="14" name="TextBox 86">
                      <a:extLst>
                        <a:ext uri="{FF2B5EF4-FFF2-40B4-BE49-F238E27FC236}">
                          <a16:creationId xmlns:a16="http://schemas.microsoft.com/office/drawing/2014/main" id="{B992D95A-5F88-0D50-D2DF-D52D00AA7338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168900" y="3337473"/>
                      <a:ext cx="936625" cy="24606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32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GB" altLang="en-US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G5</a:t>
                      </a:r>
                    </a:p>
                  </p:txBody>
                </p:sp>
                <p:grpSp>
                  <p:nvGrpSpPr>
                    <p:cNvPr id="15" name="Group 14">
                      <a:extLst>
                        <a:ext uri="{FF2B5EF4-FFF2-40B4-BE49-F238E27FC236}">
                          <a16:creationId xmlns:a16="http://schemas.microsoft.com/office/drawing/2014/main" id="{A5361E69-C272-21CF-0556-1044144F441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027238" y="403225"/>
                      <a:ext cx="5897562" cy="5792788"/>
                      <a:chOff x="2027238" y="403225"/>
                      <a:chExt cx="5897562" cy="5792788"/>
                    </a:xfrm>
                  </p:grpSpPr>
                  <p:sp>
                    <p:nvSpPr>
                      <p:cNvPr id="16" name="TextBox 95">
                        <a:extLst>
                          <a:ext uri="{FF2B5EF4-FFF2-40B4-BE49-F238E27FC236}">
                            <a16:creationId xmlns:a16="http://schemas.microsoft.com/office/drawing/2014/main" id="{297B9E5B-5265-2A44-6D7D-CE083CCB3223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2573338" y="5949950"/>
                        <a:ext cx="1763712" cy="2460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>
                        <a:lvl1pPr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32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1pPr>
                        <a:lvl2pPr marL="742950" indent="-28575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8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2pPr>
                        <a:lvl3pPr marL="11430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3pPr>
                        <a:lvl4pPr marL="16002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4pPr>
                        <a:lvl5pPr marL="20574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9pPr>
                      </a:lstStyle>
                      <a:p>
                        <a:pPr eaLnBrk="1" hangingPunct="1"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GB" altLang="en-US" sz="100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Ergosterol</a:t>
                        </a:r>
                      </a:p>
                    </p:txBody>
                  </p:sp>
                  <p:grpSp>
                    <p:nvGrpSpPr>
                      <p:cNvPr id="17" name="Group 16">
                        <a:extLst>
                          <a:ext uri="{FF2B5EF4-FFF2-40B4-BE49-F238E27FC236}">
                            <a16:creationId xmlns:a16="http://schemas.microsoft.com/office/drawing/2014/main" id="{1D0F34F7-B2BF-A255-13DD-761B6D418CB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027238" y="403225"/>
                        <a:ext cx="5897562" cy="5754688"/>
                        <a:chOff x="2027238" y="403225"/>
                        <a:chExt cx="5897562" cy="5754688"/>
                      </a:xfrm>
                    </p:grpSpPr>
                    <p:graphicFrame>
                      <p:nvGraphicFramePr>
                        <p:cNvPr id="18" name="Object 7">
                          <a:extLst>
                            <a:ext uri="{FF2B5EF4-FFF2-40B4-BE49-F238E27FC236}">
                              <a16:creationId xmlns:a16="http://schemas.microsoft.com/office/drawing/2014/main" id="{82FA39BE-2FA3-F2CD-D479-39406A15A618}"/>
                            </a:ext>
                          </a:extLst>
                        </p:cNvPr>
                        <p:cNvGraphicFramePr>
                          <a:graphicFrameLocks noChangeAspect="1"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3233820186"/>
                            </p:ext>
                          </p:extLst>
                        </p:nvPr>
                      </p:nvGraphicFramePr>
                      <p:xfrm>
                        <a:off x="2051050" y="2058988"/>
                        <a:ext cx="1090613" cy="644525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spid="_x0000_s1026" name="ISIS/Draw Sketch" r:id="rId3" imgW="2881823" imgH="1706710" progId="ISISServer">
                                <p:embed/>
                              </p:oleObj>
                            </mc:Choice>
                            <mc:Fallback>
                              <p:oleObj name="ISIS/Draw Sketch" r:id="rId3" imgW="2881823" imgH="1706710" progId="ISISServer">
                                <p:embed/>
                                <p:pic>
                                  <p:nvPicPr>
                                    <p:cNvPr id="18" name="Object 7">
                                      <a:extLst>
                                        <a:ext uri="{FF2B5EF4-FFF2-40B4-BE49-F238E27FC236}">
                                          <a16:creationId xmlns:a16="http://schemas.microsoft.com/office/drawing/2014/main" id="{82FA39BE-2FA3-F2CD-D479-39406A15A618}"/>
                                        </a:ext>
                                      </a:extLst>
                                    </p:cNvPr>
                                    <p:cNvPicPr>
                                      <a:picLocks noChangeAspect="1" noChangeArrowheads="1"/>
                                    </p:cNvPicPr>
                                    <p:nvPr/>
                                  </p:nvPicPr>
                                  <p:blipFill>
                                    <a:blip r:embed="rId4">
                                      <a:extLst>
                                        <a:ext uri="{28A0092B-C50C-407E-A947-70E740481C1C}">
                                          <a14:useLocalDpi xmlns:a14="http://schemas.microsoft.com/office/drawing/2010/main" val="0"/>
                                        </a:ext>
                                      </a:extLst>
                                    </a:blip>
                                    <a:srcRect/>
                                    <a:stretch>
                                      <a:fillRect/>
                                    </a:stretch>
                                  </p:blipFill>
                                  <p:spPr bwMode="auto">
                                    <a:xfrm>
                                      <a:off x="2051050" y="2058988"/>
                                      <a:ext cx="1090613" cy="644525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ffectLst/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chemeClr val="accent1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chemeClr val="tx1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  <a:ext uri="{AF507438-7753-43E0-B8FC-AC1667EBCBE1}">
                                        <a14:hiddenEffects xmlns:a14="http://schemas.microsoft.com/office/drawing/2010/main">
                                          <a:effectLst>
                                            <a:outerShdw dist="35921" dir="2700000" algn="ctr" rotWithShape="0">
                                              <a:schemeClr val="bg2"/>
                                            </a:outerShdw>
                                          </a:effectLst>
                                        </a14:hiddenEffects>
                                      </a:ext>
                                    </a:extLst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graphicFrame>
                      <p:nvGraphicFramePr>
                        <p:cNvPr id="19" name="Object 8">
                          <a:extLst>
                            <a:ext uri="{FF2B5EF4-FFF2-40B4-BE49-F238E27FC236}">
                              <a16:creationId xmlns:a16="http://schemas.microsoft.com/office/drawing/2014/main" id="{160ACD2C-4B57-7A43-A424-6F834830DA9D}"/>
                            </a:ext>
                          </a:extLst>
                        </p:cNvPr>
                        <p:cNvGraphicFramePr>
                          <a:graphicFrameLocks noChangeAspect="1"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2522213826"/>
                            </p:ext>
                          </p:extLst>
                        </p:nvPr>
                      </p:nvGraphicFramePr>
                      <p:xfrm>
                        <a:off x="2051050" y="3211513"/>
                        <a:ext cx="1085850" cy="641350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spid="_x0000_s1027" name="ISIS/Draw Sketch" r:id="rId5" imgW="2881823" imgH="1706710" progId="ISISServer">
                                <p:embed/>
                              </p:oleObj>
                            </mc:Choice>
                            <mc:Fallback>
                              <p:oleObj name="ISIS/Draw Sketch" r:id="rId5" imgW="2881823" imgH="1706710" progId="ISISServer">
                                <p:embed/>
                                <p:pic>
                                  <p:nvPicPr>
                                    <p:cNvPr id="19" name="Object 8">
                                      <a:extLst>
                                        <a:ext uri="{FF2B5EF4-FFF2-40B4-BE49-F238E27FC236}">
                                          <a16:creationId xmlns:a16="http://schemas.microsoft.com/office/drawing/2014/main" id="{160ACD2C-4B57-7A43-A424-6F834830DA9D}"/>
                                        </a:ext>
                                      </a:extLst>
                                    </p:cNvPr>
                                    <p:cNvPicPr>
                                      <a:picLocks noChangeAspect="1" noChangeArrowheads="1"/>
                                    </p:cNvPicPr>
                                    <p:nvPr/>
                                  </p:nvPicPr>
                                  <p:blipFill>
                                    <a:blip r:embed="rId6">
                                      <a:extLst>
                                        <a:ext uri="{28A0092B-C50C-407E-A947-70E740481C1C}">
                                          <a14:useLocalDpi xmlns:a14="http://schemas.microsoft.com/office/drawing/2010/main" val="0"/>
                                        </a:ext>
                                      </a:extLst>
                                    </a:blip>
                                    <a:srcRect/>
                                    <a:stretch>
                                      <a:fillRect/>
                                    </a:stretch>
                                  </p:blipFill>
                                  <p:spPr bwMode="auto">
                                    <a:xfrm>
                                      <a:off x="2051050" y="3211513"/>
                                      <a:ext cx="1085850" cy="641350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ffectLst/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chemeClr val="accent1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chemeClr val="tx1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  <a:ext uri="{AF507438-7753-43E0-B8FC-AC1667EBCBE1}">
                                        <a14:hiddenEffects xmlns:a14="http://schemas.microsoft.com/office/drawing/2010/main">
                                          <a:effectLst>
                                            <a:outerShdw dist="35921" dir="2700000" algn="ctr" rotWithShape="0">
                                              <a:schemeClr val="bg2"/>
                                            </a:outerShdw>
                                          </a:effectLst>
                                        </a14:hiddenEffects>
                                      </a:ext>
                                    </a:extLst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graphicFrame>
                      <p:nvGraphicFramePr>
                        <p:cNvPr id="20" name="Object 10">
                          <a:extLst>
                            <a:ext uri="{FF2B5EF4-FFF2-40B4-BE49-F238E27FC236}">
                              <a16:creationId xmlns:a16="http://schemas.microsoft.com/office/drawing/2014/main" id="{E099A3EF-E119-5C9C-9636-E256FDAE33C2}"/>
                            </a:ext>
                          </a:extLst>
                        </p:cNvPr>
                        <p:cNvGraphicFramePr>
                          <a:graphicFrameLocks noChangeAspect="1"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518068272"/>
                            </p:ext>
                          </p:extLst>
                        </p:nvPr>
                      </p:nvGraphicFramePr>
                      <p:xfrm>
                        <a:off x="2027238" y="5516563"/>
                        <a:ext cx="1087437" cy="641350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spid="_x0000_s1028" name="ISIS/Draw Sketch" r:id="rId7" imgW="2881823" imgH="1706710" progId="ISISServer">
                                <p:embed/>
                              </p:oleObj>
                            </mc:Choice>
                            <mc:Fallback>
                              <p:oleObj name="ISIS/Draw Sketch" r:id="rId7" imgW="2881823" imgH="1706710" progId="ISISServer">
                                <p:embed/>
                                <p:pic>
                                  <p:nvPicPr>
                                    <p:cNvPr id="20" name="Object 10">
                                      <a:extLst>
                                        <a:ext uri="{FF2B5EF4-FFF2-40B4-BE49-F238E27FC236}">
                                          <a16:creationId xmlns:a16="http://schemas.microsoft.com/office/drawing/2014/main" id="{E099A3EF-E119-5C9C-9636-E256FDAE33C2}"/>
                                        </a:ext>
                                      </a:extLst>
                                    </p:cNvPr>
                                    <p:cNvPicPr>
                                      <a:picLocks noChangeAspect="1" noChangeArrowheads="1"/>
                                    </p:cNvPicPr>
                                    <p:nvPr/>
                                  </p:nvPicPr>
                                  <p:blipFill>
                                    <a:blip r:embed="rId8">
                                      <a:extLst>
                                        <a:ext uri="{28A0092B-C50C-407E-A947-70E740481C1C}">
                                          <a14:useLocalDpi xmlns:a14="http://schemas.microsoft.com/office/drawing/2010/main" val="0"/>
                                        </a:ext>
                                      </a:extLst>
                                    </a:blip>
                                    <a:srcRect/>
                                    <a:stretch>
                                      <a:fillRect/>
                                    </a:stretch>
                                  </p:blipFill>
                                  <p:spPr bwMode="auto">
                                    <a:xfrm>
                                      <a:off x="2027238" y="5516563"/>
                                      <a:ext cx="1087437" cy="641350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ffectLst/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chemeClr val="accent1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chemeClr val="tx1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  <a:ext uri="{AF507438-7753-43E0-B8FC-AC1667EBCBE1}">
                                        <a14:hiddenEffects xmlns:a14="http://schemas.microsoft.com/office/drawing/2010/main">
                                          <a:effectLst>
                                            <a:outerShdw dist="35921" dir="2700000" algn="ctr" rotWithShape="0">
                                              <a:schemeClr val="bg2"/>
                                            </a:outerShdw>
                                          </a:effectLst>
                                        </a14:hiddenEffects>
                                      </a:ext>
                                    </a:extLst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graphicFrame>
                      <p:nvGraphicFramePr>
                        <p:cNvPr id="21" name="Object 11">
                          <a:extLst>
                            <a:ext uri="{FF2B5EF4-FFF2-40B4-BE49-F238E27FC236}">
                              <a16:creationId xmlns:a16="http://schemas.microsoft.com/office/drawing/2014/main" id="{1E04481C-D840-78B8-9623-81A1D0509F46}"/>
                            </a:ext>
                          </a:extLst>
                        </p:cNvPr>
                        <p:cNvGraphicFramePr>
                          <a:graphicFrameLocks noChangeAspect="1"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550569278"/>
                            </p:ext>
                          </p:extLst>
                        </p:nvPr>
                      </p:nvGraphicFramePr>
                      <p:xfrm>
                        <a:off x="5668963" y="3211513"/>
                        <a:ext cx="1093787" cy="646112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spid="_x0000_s1029" name="ISIS/Draw Sketch" r:id="rId9" imgW="2881823" imgH="1706710" progId="ISISServer">
                                <p:embed/>
                              </p:oleObj>
                            </mc:Choice>
                            <mc:Fallback>
                              <p:oleObj name="ISIS/Draw Sketch" r:id="rId9" imgW="2881823" imgH="1706710" progId="ISISServer">
                                <p:embed/>
                                <p:pic>
                                  <p:nvPicPr>
                                    <p:cNvPr id="21" name="Object 11">
                                      <a:extLst>
                                        <a:ext uri="{FF2B5EF4-FFF2-40B4-BE49-F238E27FC236}">
                                          <a16:creationId xmlns:a16="http://schemas.microsoft.com/office/drawing/2014/main" id="{1E04481C-D840-78B8-9623-81A1D0509F46}"/>
                                        </a:ext>
                                      </a:extLst>
                                    </p:cNvPr>
                                    <p:cNvPicPr>
                                      <a:picLocks noChangeAspect="1" noChangeArrowheads="1"/>
                                    </p:cNvPicPr>
                                    <p:nvPr/>
                                  </p:nvPicPr>
                                  <p:blipFill>
                                    <a:blip r:embed="rId10">
                                      <a:extLst>
                                        <a:ext uri="{28A0092B-C50C-407E-A947-70E740481C1C}">
                                          <a14:useLocalDpi xmlns:a14="http://schemas.microsoft.com/office/drawing/2010/main" val="0"/>
                                        </a:ext>
                                      </a:extLst>
                                    </a:blip>
                                    <a:srcRect/>
                                    <a:stretch>
                                      <a:fillRect/>
                                    </a:stretch>
                                  </p:blipFill>
                                  <p:spPr bwMode="auto">
                                    <a:xfrm>
                                      <a:off x="5668963" y="3211513"/>
                                      <a:ext cx="1093787" cy="646112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ffectLst/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chemeClr val="accent1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chemeClr val="tx1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  <a:ext uri="{AF507438-7753-43E0-B8FC-AC1667EBCBE1}">
                                        <a14:hiddenEffects xmlns:a14="http://schemas.microsoft.com/office/drawing/2010/main">
                                          <a:effectLst>
                                            <a:outerShdw dist="35921" dir="2700000" algn="ctr" rotWithShape="0">
                                              <a:schemeClr val="bg2"/>
                                            </a:outerShdw>
                                          </a:effectLst>
                                        </a14:hiddenEffects>
                                      </a:ext>
                                    </a:extLst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graphicFrame>
                      <p:nvGraphicFramePr>
                        <p:cNvPr id="22" name="Object 12">
                          <a:extLst>
                            <a:ext uri="{FF2B5EF4-FFF2-40B4-BE49-F238E27FC236}">
                              <a16:creationId xmlns:a16="http://schemas.microsoft.com/office/drawing/2014/main" id="{45CDF4AE-A699-B960-D1A2-5649799048BA}"/>
                            </a:ext>
                          </a:extLst>
                        </p:cNvPr>
                        <p:cNvGraphicFramePr>
                          <a:graphicFrameLocks noChangeAspect="1"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2460928104"/>
                            </p:ext>
                          </p:extLst>
                        </p:nvPr>
                      </p:nvGraphicFramePr>
                      <p:xfrm>
                        <a:off x="4010025" y="3211513"/>
                        <a:ext cx="1103313" cy="650875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spid="_x0000_s1030" name="ISIS/Draw Sketch" r:id="rId11" imgW="2881823" imgH="1706710" progId="ISISServer">
                                <p:embed/>
                              </p:oleObj>
                            </mc:Choice>
                            <mc:Fallback>
                              <p:oleObj name="ISIS/Draw Sketch" r:id="rId11" imgW="2881823" imgH="1706710" progId="ISISServer">
                                <p:embed/>
                                <p:pic>
                                  <p:nvPicPr>
                                    <p:cNvPr id="22" name="Object 12">
                                      <a:extLst>
                                        <a:ext uri="{FF2B5EF4-FFF2-40B4-BE49-F238E27FC236}">
                                          <a16:creationId xmlns:a16="http://schemas.microsoft.com/office/drawing/2014/main" id="{45CDF4AE-A699-B960-D1A2-5649799048BA}"/>
                                        </a:ext>
                                      </a:extLst>
                                    </p:cNvPr>
                                    <p:cNvPicPr>
                                      <a:picLocks noChangeAspect="1" noChangeArrowheads="1"/>
                                    </p:cNvPicPr>
                                    <p:nvPr/>
                                  </p:nvPicPr>
                                  <p:blipFill>
                                    <a:blip r:embed="rId12">
                                      <a:extLst>
                                        <a:ext uri="{28A0092B-C50C-407E-A947-70E740481C1C}">
                                          <a14:useLocalDpi xmlns:a14="http://schemas.microsoft.com/office/drawing/2010/main" val="0"/>
                                        </a:ext>
                                      </a:extLst>
                                    </a:blip>
                                    <a:srcRect/>
                                    <a:stretch>
                                      <a:fillRect/>
                                    </a:stretch>
                                  </p:blipFill>
                                  <p:spPr bwMode="auto">
                                    <a:xfrm>
                                      <a:off x="4010025" y="3211513"/>
                                      <a:ext cx="1103313" cy="650875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ffectLst/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chemeClr val="accent1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chemeClr val="tx1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  <a:ext uri="{AF507438-7753-43E0-B8FC-AC1667EBCBE1}">
                                        <a14:hiddenEffects xmlns:a14="http://schemas.microsoft.com/office/drawing/2010/main">
                                          <a:effectLst>
                                            <a:outerShdw dist="35921" dir="2700000" algn="ctr" rotWithShape="0">
                                              <a:schemeClr val="bg2"/>
                                            </a:outerShdw>
                                          </a:effectLst>
                                        </a14:hiddenEffects>
                                      </a:ext>
                                    </a:extLst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graphicFrame>
                      <p:nvGraphicFramePr>
                        <p:cNvPr id="23" name="Object 17">
                          <a:extLst>
                            <a:ext uri="{FF2B5EF4-FFF2-40B4-BE49-F238E27FC236}">
                              <a16:creationId xmlns:a16="http://schemas.microsoft.com/office/drawing/2014/main" id="{2005BDBB-EBBD-6367-F223-1D96A38FDC57}"/>
                            </a:ext>
                          </a:extLst>
                        </p:cNvPr>
                        <p:cNvGraphicFramePr>
                          <a:graphicFrameLocks noChangeAspect="1"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1708109959"/>
                            </p:ext>
                          </p:extLst>
                        </p:nvPr>
                      </p:nvGraphicFramePr>
                      <p:xfrm>
                        <a:off x="5651500" y="2060575"/>
                        <a:ext cx="1093788" cy="642938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spid="_x0000_s1031" name="ISIS/Draw Sketch" r:id="rId13" imgW="2881630" imgH="1700530" progId="ISISServer">
                                <p:embed/>
                              </p:oleObj>
                            </mc:Choice>
                            <mc:Fallback>
                              <p:oleObj name="ISIS/Draw Sketch" r:id="rId13" imgW="2881630" imgH="1700530" progId="ISISServer">
                                <p:embed/>
                                <p:pic>
                                  <p:nvPicPr>
                                    <p:cNvPr id="23" name="Object 17">
                                      <a:extLst>
                                        <a:ext uri="{FF2B5EF4-FFF2-40B4-BE49-F238E27FC236}">
                                          <a16:creationId xmlns:a16="http://schemas.microsoft.com/office/drawing/2014/main" id="{2005BDBB-EBBD-6367-F223-1D96A38FDC57}"/>
                                        </a:ext>
                                      </a:extLst>
                                    </p:cNvPr>
                                    <p:cNvPicPr>
                                      <a:picLocks noChangeAspect="1" noChangeArrowheads="1"/>
                                    </p:cNvPicPr>
                                    <p:nvPr/>
                                  </p:nvPicPr>
                                  <p:blipFill>
                                    <a:blip r:embed="rId14">
                                      <a:extLst>
                                        <a:ext uri="{28A0092B-C50C-407E-A947-70E740481C1C}">
                                          <a14:useLocalDpi xmlns:a14="http://schemas.microsoft.com/office/drawing/2010/main" val="0"/>
                                        </a:ext>
                                      </a:extLst>
                                    </a:blip>
                                    <a:srcRect/>
                                    <a:stretch>
                                      <a:fillRect/>
                                    </a:stretch>
                                  </p:blipFill>
                                  <p:spPr bwMode="auto">
                                    <a:xfrm>
                                      <a:off x="5651500" y="2060575"/>
                                      <a:ext cx="1093788" cy="642938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>
                                      <a:noFill/>
                                    </a:ln>
                                    <a:effectLst/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chemeClr val="accent1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>
                                          <a:solidFill>
                                            <a:schemeClr val="tx1"/>
                                          </a:solidFill>
                                          <a:miter lim="800000"/>
                                          <a:headEnd/>
                                          <a:tailEnd/>
                                        </a14:hiddenLine>
                                      </a:ext>
                                      <a:ext uri="{AF507438-7753-43E0-B8FC-AC1667EBCBE1}">
                                        <a14:hiddenEffects xmlns:a14="http://schemas.microsoft.com/office/drawing/2010/main">
                                          <a:effectLst>
                                            <a:outerShdw dist="35921" dir="2700000" algn="ctr" rotWithShape="0">
                                              <a:schemeClr val="bg2"/>
                                            </a:outerShdw>
                                          </a:effectLst>
                                        </a14:hiddenEffects>
                                      </a:ext>
                                    </a:extLst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sp>
                      <p:nvSpPr>
                        <p:cNvPr id="24" name="TextBox 48">
                          <a:extLst>
                            <a:ext uri="{FF2B5EF4-FFF2-40B4-BE49-F238E27FC236}">
                              <a16:creationId xmlns:a16="http://schemas.microsoft.com/office/drawing/2014/main" id="{3129830A-FF46-3F5F-6921-185E0769AD88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55875" y="4046538"/>
                          <a:ext cx="1511300" cy="2460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 b="1" i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5</a:t>
                          </a:r>
                        </a:p>
                      </p:txBody>
                    </p:sp>
                    <p:sp>
                      <p:nvSpPr>
                        <p:cNvPr id="25" name="TextBox 71">
                          <a:extLst>
                            <a:ext uri="{FF2B5EF4-FFF2-40B4-BE49-F238E27FC236}">
                              <a16:creationId xmlns:a16="http://schemas.microsoft.com/office/drawing/2014/main" id="{DABA5405-8E67-DCA9-18A7-C27558F00BCA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55875" y="2851150"/>
                          <a:ext cx="1511300" cy="400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 b="1" i="1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3</a:t>
                          </a:r>
                          <a:r>
                            <a:rPr lang="en-GB" altLang="en-US" sz="1000" b="1" i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 </a:t>
                          </a:r>
                        </a:p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endParaRPr lang="en-GB" altLang="en-US" sz="1000" b="1" i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cxnSp>
                      <p:nvCxnSpPr>
                        <p:cNvPr id="26" name="Straight Arrow Connector 25">
                          <a:extLst>
                            <a:ext uri="{FF2B5EF4-FFF2-40B4-BE49-F238E27FC236}">
                              <a16:creationId xmlns:a16="http://schemas.microsoft.com/office/drawing/2014/main" id="{90B9BF3B-422C-6076-ACD1-DA65E0215700}"/>
                            </a:ext>
                          </a:extLst>
                        </p:cNvPr>
                        <p:cNvCxnSpPr/>
                        <p:nvPr/>
                      </p:nvCxnSpPr>
                      <p:spPr bwMode="auto">
                        <a:xfrm>
                          <a:off x="3275013" y="2346325"/>
                          <a:ext cx="2592387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7" name="Straight Arrow Connector 26">
                          <a:extLst>
                            <a:ext uri="{FF2B5EF4-FFF2-40B4-BE49-F238E27FC236}">
                              <a16:creationId xmlns:a16="http://schemas.microsoft.com/office/drawing/2014/main" id="{021A9C55-E0CB-F1D1-457B-E3C7CE9F9A41}"/>
                            </a:ext>
                          </a:extLst>
                        </p:cNvPr>
                        <p:cNvCxnSpPr/>
                        <p:nvPr/>
                      </p:nvCxnSpPr>
                      <p:spPr bwMode="auto">
                        <a:xfrm>
                          <a:off x="3275013" y="2417763"/>
                          <a:ext cx="1008062" cy="936625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8" name="Straight Arrow Connector 27">
                          <a:extLst>
                            <a:ext uri="{FF2B5EF4-FFF2-40B4-BE49-F238E27FC236}">
                              <a16:creationId xmlns:a16="http://schemas.microsoft.com/office/drawing/2014/main" id="{5AD8C09B-5F2E-A170-0A35-4B810AAA7AA9}"/>
                            </a:ext>
                          </a:extLst>
                        </p:cNvPr>
                        <p:cNvCxnSpPr/>
                        <p:nvPr/>
                      </p:nvCxnSpPr>
                      <p:spPr bwMode="auto">
                        <a:xfrm>
                          <a:off x="6146800" y="2730500"/>
                          <a:ext cx="0" cy="639763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9" name="TextBox 84">
                          <a:extLst>
                            <a:ext uri="{FF2B5EF4-FFF2-40B4-BE49-F238E27FC236}">
                              <a16:creationId xmlns:a16="http://schemas.microsoft.com/office/drawing/2014/main" id="{3439DB04-6952-59F9-F303-1F1F6223F72D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643438" y="2130425"/>
                          <a:ext cx="936625" cy="2460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 b="1" i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5</a:t>
                          </a:r>
                        </a:p>
                      </p:txBody>
                    </p:sp>
                    <p:sp>
                      <p:nvSpPr>
                        <p:cNvPr id="30" name="TextBox 85">
                          <a:extLst>
                            <a:ext uri="{FF2B5EF4-FFF2-40B4-BE49-F238E27FC236}">
                              <a16:creationId xmlns:a16="http://schemas.microsoft.com/office/drawing/2014/main" id="{605E6899-D10C-93ED-3416-1FA56CA651E7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779838" y="2779713"/>
                          <a:ext cx="936625" cy="2460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 b="1" i="1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4</a:t>
                          </a:r>
                        </a:p>
                      </p:txBody>
                    </p:sp>
                    <p:sp>
                      <p:nvSpPr>
                        <p:cNvPr id="31" name="TextBox 87">
                          <a:extLst>
                            <a:ext uri="{FF2B5EF4-FFF2-40B4-BE49-F238E27FC236}">
                              <a16:creationId xmlns:a16="http://schemas.microsoft.com/office/drawing/2014/main" id="{34A89F33-7603-AA80-53EB-465E3880C7F4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6115050" y="2922588"/>
                          <a:ext cx="936625" cy="2460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 b="1" i="1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4</a:t>
                          </a:r>
                        </a:p>
                      </p:txBody>
                    </p:sp>
                    <p:sp>
                      <p:nvSpPr>
                        <p:cNvPr id="32" name="TextBox 88">
                          <a:extLst>
                            <a:ext uri="{FF2B5EF4-FFF2-40B4-BE49-F238E27FC236}">
                              <a16:creationId xmlns:a16="http://schemas.microsoft.com/office/drawing/2014/main" id="{3BEC2851-6551-4976-7421-6A5C9FD6EC49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6161088" y="2438400"/>
                          <a:ext cx="1512887" cy="400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osta 7,22,24(28) -trienol</a:t>
                          </a:r>
                        </a:p>
                      </p:txBody>
                    </p:sp>
                    <p:sp>
                      <p:nvSpPr>
                        <p:cNvPr id="33" name="TextBox 89">
                          <a:extLst>
                            <a:ext uri="{FF2B5EF4-FFF2-40B4-BE49-F238E27FC236}">
                              <a16:creationId xmlns:a16="http://schemas.microsoft.com/office/drawing/2014/main" id="{7C408E27-C2CC-D89B-A15E-66998FCDA830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500563" y="3613150"/>
                          <a:ext cx="1763712" cy="2460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osta 7-enol</a:t>
                          </a:r>
                        </a:p>
                      </p:txBody>
                    </p:sp>
                    <p:sp>
                      <p:nvSpPr>
                        <p:cNvPr id="34" name="TextBox 90">
                          <a:extLst>
                            <a:ext uri="{FF2B5EF4-FFF2-40B4-BE49-F238E27FC236}">
                              <a16:creationId xmlns:a16="http://schemas.microsoft.com/office/drawing/2014/main" id="{E3E59037-A1F8-8454-3048-12C93637238E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6161088" y="3613150"/>
                          <a:ext cx="1763712" cy="2460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osta 7,22 -dienol</a:t>
                          </a:r>
                        </a:p>
                      </p:txBody>
                    </p:sp>
                    <p:sp>
                      <p:nvSpPr>
                        <p:cNvPr id="35" name="TextBox 104">
                          <a:extLst>
                            <a:ext uri="{FF2B5EF4-FFF2-40B4-BE49-F238E27FC236}">
                              <a16:creationId xmlns:a16="http://schemas.microsoft.com/office/drawing/2014/main" id="{BE570910-0EDD-0A03-488D-B7BABE123194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73338" y="2460625"/>
                          <a:ext cx="1763712" cy="2460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pisterol</a:t>
                          </a:r>
                        </a:p>
                      </p:txBody>
                    </p:sp>
                    <p:sp>
                      <p:nvSpPr>
                        <p:cNvPr id="36" name="TextBox 105">
                          <a:extLst>
                            <a:ext uri="{FF2B5EF4-FFF2-40B4-BE49-F238E27FC236}">
                              <a16:creationId xmlns:a16="http://schemas.microsoft.com/office/drawing/2014/main" id="{0088669B-25EE-2DF6-1EB3-5C8D5BC26B59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73338" y="3613150"/>
                          <a:ext cx="1508125" cy="400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osta 5,7,24(28) -trienol</a:t>
                          </a:r>
                        </a:p>
                      </p:txBody>
                    </p:sp>
                    <p:pic>
                      <p:nvPicPr>
                        <p:cNvPr id="37" name="Picture 5">
                          <a:extLst>
                            <a:ext uri="{FF2B5EF4-FFF2-40B4-BE49-F238E27FC236}">
                              <a16:creationId xmlns:a16="http://schemas.microsoft.com/office/drawing/2014/main" id="{F4D7568E-8EAE-FEEF-978A-9F26D023AE22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027238" y="1052513"/>
                          <a:ext cx="1093787" cy="64611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  <p:sp>
                      <p:nvSpPr>
                        <p:cNvPr id="38" name="TextBox 85">
                          <a:extLst>
                            <a:ext uri="{FF2B5EF4-FFF2-40B4-BE49-F238E27FC236}">
                              <a16:creationId xmlns:a16="http://schemas.microsoft.com/office/drawing/2014/main" id="{67C0F04A-1728-06E6-BBF5-C87B47C053A0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55875" y="1700213"/>
                          <a:ext cx="936625" cy="2460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 b="1" i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2</a:t>
                          </a:r>
                        </a:p>
                      </p:txBody>
                    </p:sp>
                    <p:sp>
                      <p:nvSpPr>
                        <p:cNvPr id="39" name="TextBox 100">
                          <a:extLst>
                            <a:ext uri="{FF2B5EF4-FFF2-40B4-BE49-F238E27FC236}">
                              <a16:creationId xmlns:a16="http://schemas.microsoft.com/office/drawing/2014/main" id="{C5768C71-5A44-B82D-5F2B-E6E8B9C61F53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06675" y="1425575"/>
                          <a:ext cx="1763713" cy="2460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Fecosterol</a:t>
                          </a:r>
                        </a:p>
                      </p:txBody>
                    </p:sp>
                    <p:cxnSp>
                      <p:nvCxnSpPr>
                        <p:cNvPr id="40" name="Straight Arrow Connector 39">
                          <a:extLst>
                            <a:ext uri="{FF2B5EF4-FFF2-40B4-BE49-F238E27FC236}">
                              <a16:creationId xmlns:a16="http://schemas.microsoft.com/office/drawing/2014/main" id="{84288A9D-329E-01F7-6901-BB49E739DC64}"/>
                            </a:ext>
                          </a:extLst>
                        </p:cNvPr>
                        <p:cNvCxnSpPr/>
                        <p:nvPr/>
                      </p:nvCxnSpPr>
                      <p:spPr bwMode="auto">
                        <a:xfrm>
                          <a:off x="2628900" y="403225"/>
                          <a:ext cx="0" cy="741363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prstDash val="dash"/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1" name="TextBox 48">
                          <a:extLst>
                            <a:ext uri="{FF2B5EF4-FFF2-40B4-BE49-F238E27FC236}">
                              <a16:creationId xmlns:a16="http://schemas.microsoft.com/office/drawing/2014/main" id="{67467641-F885-38DA-DB16-62DC8DDC40C5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55875" y="5199063"/>
                          <a:ext cx="1511300" cy="2460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 b="1" i="1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4</a:t>
                          </a:r>
                        </a:p>
                      </p:txBody>
                    </p:sp>
                    <p:cxnSp>
                      <p:nvCxnSpPr>
                        <p:cNvPr id="42" name="Straight Arrow Connector 41">
                          <a:extLst>
                            <a:ext uri="{FF2B5EF4-FFF2-40B4-BE49-F238E27FC236}">
                              <a16:creationId xmlns:a16="http://schemas.microsoft.com/office/drawing/2014/main" id="{2A29936D-054B-89F8-8E58-A937E334E7C1}"/>
                            </a:ext>
                          </a:extLst>
                        </p:cNvPr>
                        <p:cNvCxnSpPr/>
                        <p:nvPr/>
                      </p:nvCxnSpPr>
                      <p:spPr bwMode="auto">
                        <a:xfrm flipH="1">
                          <a:off x="2592388" y="5013325"/>
                          <a:ext cx="0" cy="563563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3" name="TextBox 105">
                          <a:extLst>
                            <a:ext uri="{FF2B5EF4-FFF2-40B4-BE49-F238E27FC236}">
                              <a16:creationId xmlns:a16="http://schemas.microsoft.com/office/drawing/2014/main" id="{EBD1D37A-243D-AF2A-6A46-997BC3EBE757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84450" y="4757738"/>
                          <a:ext cx="1508125" cy="400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>
                          <a:spAutoFit/>
                        </a:bodyPr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GB" altLang="en-US" sz="100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rgosta 5,7,22, 24(28) -tetraenol</a:t>
                          </a:r>
                        </a:p>
                      </p:txBody>
                    </p:sp>
                    <p:pic>
                      <p:nvPicPr>
                        <p:cNvPr id="44" name="Picture 6">
                          <a:extLst>
                            <a:ext uri="{FF2B5EF4-FFF2-40B4-BE49-F238E27FC236}">
                              <a16:creationId xmlns:a16="http://schemas.microsoft.com/office/drawing/2014/main" id="{B8F5C42A-93C1-8E82-DD28-C17C2D57C4C3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027238" y="4356100"/>
                          <a:ext cx="1093787" cy="6461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grpSp>
                </p:grpSp>
              </p:grpSp>
            </p:grpSp>
          </p:grpSp>
        </p:grpSp>
      </p:grpSp>
      <p:sp>
        <p:nvSpPr>
          <p:cNvPr id="45" name="TextBox 10">
            <a:extLst>
              <a:ext uri="{FF2B5EF4-FFF2-40B4-BE49-F238E27FC236}">
                <a16:creationId xmlns:a16="http://schemas.microsoft.com/office/drawing/2014/main" id="{933A2078-D953-1441-F685-51AE70E4ED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76870" y="5254625"/>
            <a:ext cx="2391920" cy="1169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G2</a:t>
            </a:r>
            <a:r>
              <a:rPr lang="en-GB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,7 Isomeras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G3</a:t>
            </a:r>
            <a:r>
              <a:rPr lang="en-GB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,6 Desaturas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G4</a:t>
            </a:r>
            <a:r>
              <a:rPr lang="en-GB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4 Reductas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G5</a:t>
            </a:r>
            <a:r>
              <a:rPr lang="en-GB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2 Desaturas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G6</a:t>
            </a:r>
            <a:r>
              <a:rPr lang="en-GB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4 Methyltransferase</a:t>
            </a:r>
          </a:p>
        </p:txBody>
      </p:sp>
    </p:spTree>
    <p:extLst>
      <p:ext uri="{BB962C8B-B14F-4D97-AF65-F5344CB8AC3E}">
        <p14:creationId xmlns:p14="http://schemas.microsoft.com/office/powerpoint/2010/main" val="26648216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92D47-E0E7-4E66-8D1A-774AE3AAD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3996193" cy="1325563"/>
          </a:xfrm>
        </p:spPr>
        <p:txBody>
          <a:bodyPr/>
          <a:lstStyle/>
          <a:p>
            <a:r>
              <a:rPr lang="en-US" dirty="0"/>
              <a:t>Supp. Table 1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0D2CA43-1412-443A-81EF-F929B5A4D4D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9924374"/>
              </p:ext>
            </p:extLst>
          </p:nvPr>
        </p:nvGraphicFramePr>
        <p:xfrm>
          <a:off x="5685756" y="597784"/>
          <a:ext cx="5056455" cy="5783773"/>
        </p:xfrm>
        <a:graphic>
          <a:graphicData uri="http://schemas.openxmlformats.org/drawingml/2006/table">
            <a:tbl>
              <a:tblPr firstRow="1" firstCol="1" bandRow="1"/>
              <a:tblGrid>
                <a:gridCol w="1469397">
                  <a:extLst>
                    <a:ext uri="{9D8B030D-6E8A-4147-A177-3AD203B41FA5}">
                      <a16:colId xmlns:a16="http://schemas.microsoft.com/office/drawing/2014/main" val="3326048703"/>
                    </a:ext>
                  </a:extLst>
                </a:gridCol>
                <a:gridCol w="3587058">
                  <a:extLst>
                    <a:ext uri="{9D8B030D-6E8A-4147-A177-3AD203B41FA5}">
                      <a16:colId xmlns:a16="http://schemas.microsoft.com/office/drawing/2014/main" val="2096899194"/>
                    </a:ext>
                  </a:extLst>
                </a:gridCol>
              </a:tblGrid>
              <a:tr h="20185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. auris </a:t>
                      </a: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rai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 anchor="b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 anchor="b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9564672"/>
                  </a:ext>
                </a:extLst>
              </a:tr>
              <a:tr h="21531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NV002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otype: 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71fs..S261*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106*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5469204"/>
                  </a:ext>
                </a:extLst>
              </a:tr>
              <a:tr h="19302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NV002_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otype: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ERG3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106*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7362359"/>
                  </a:ext>
                </a:extLst>
              </a:tr>
              <a:tr h="2211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NV002_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otype: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ERG3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1725978"/>
                  </a:ext>
                </a:extLst>
              </a:tr>
              <a:tr h="20185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Blocks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6730673"/>
                  </a:ext>
                </a:extLst>
              </a:tr>
              <a:tr h="24886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</a:t>
                      </a:r>
                      <a:r>
                        <a:rPr lang="en-US" sz="8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Block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GTGCCGTAAATACCCGCCTGGAGCCTCCTCTACCAGAACGTTTATAAAAGCCCACCTCCTTCCTTATTACAGAAGCCGAAGTATCACTGCAATTCACCATGGATATTGTGTTGGAAATCGCAGATTCCTTTCTTCTTGATAAGCTTTACGCCAAAGCGTTGCCCAAGGATGGAGCAGTGGCTCAATATATCGCTAACAACTTTGGCAGCAAAAACGCTACCGCTCCGGCCCAGGGGCTCCACATGCCTGCGCCAGTGACTTATTTGGCCTCTTTGGCTGGCAAACTtCAGAGAAAAGACGAAGTTTACGGCCACTTCCCCCAGTTTTTTGATTTCGATGAATACACCAACGCGTCGCTTCTCTCAAGAAGCAATCTCATCAGAGAGTTTGTATCCATCTTCTTTATCACTGCTATTTTCGGATGGATTCTTTACTTTTCTGTGGCGTCCTTCTCGTATTTCTTCGTGTTTGACAAGAAGATTTTCAACCACCCAAGGTACTTGAAGAACCAAGTGTCTTTGGAAATCTGGCGTGCTACTACTGCCATCCCAGTGATGGTGCTTCTCACAGTGCCTTTCTTCATGGCAGAACTCAACGGATTCTCCAAGCTTTACTTTAACGTGGACGAGTCCACCGGCGGTTGGAAAGCCGTATTGTTACAGTTCCCCTTCTTCATTTTGTTCACCGACTGCGGCATCTACTTCATCCACCGCTGGCTACACTGGCCATCCGTGTACAAGAAGCTCCACAAGCCCCACCACAAGTGGATTGTTTGCACCCCATTCGCTTCGCACGCTTTCCACCCAGTTGACGGATGGTTCCAGTCGTTACCTTACCACCTCTACCCCATGGTGTTCCCGTTGCACAAGGTTTCCTAC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2562310"/>
                  </a:ext>
                </a:extLst>
              </a:tr>
              <a:tr h="226190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</a:t>
                      </a:r>
                      <a:r>
                        <a:rPr lang="en-US" sz="8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Block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TATCAATTGATTGGCTTGCTTTTGGACATTCGTTCATAAACGAGGCAATTGCAAAGATGGCAAGAAAAGCGACCAAGGAAAAGGAGTCTTCACAAGTTGTCCCCAGCGGCTACTTGGCACCCGAGGATATTGAGTGGGAATTTGGTGGTCCAATCGGTGCGTTCGGCATGATGACCGGCTTCCCCCTTTTAATGATCTACATGTGGTTAAGTGCTGAATTTTTTGGTGGAAAACCTGCGTGGCCTGCTGAGGGCCAGAGCTGGGAGAGCTTTGGAAAACAACTCTGGAATTTGTTTGTGACACACGGAGTGCCTTCATTCACCTCCTGGGCCCTATTCACCGGCTTCTTTGTTGTGCAGGCtATCTTTTACTTGACTTTGCCTGGAATATGGACTAAAGGTCAGCCTTTGACTCACTTGAAGAACAAGCAGTTGCCATACTATTGTAATGCCGTGTCCGCCTTCTACACTACTAATGTTGTGGTGTTGGCGTTGCACGCTGCTGGTTACAAGTTATATTATATCATTGACAACTTCGGTGAGATCATGGTCACTGCCATCTCCTATGGTCTTTCGTTGTCTGTGTTGTTGTACATTTACTGCCTCAATGTGTCGAAGGACTACCACAGAATGACTGGCAATCACATTTACGACTGCTTCATGGGTGCTCCATTGAACCCCAGAATCGGCAAGTACTTAGACTTGAAGATGTTCTTTGAAGTCAGAATCCCATGGTTTACCTTGTACTTCCTCTCTCTTGCTACCGCTTTGAAGCAGTACGATAACTTTGGGTACGTCAGC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169" marR="34169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5967140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59467285-FCB3-46BF-BC75-2A0433BCD6F2}"/>
              </a:ext>
            </a:extLst>
          </p:cNvPr>
          <p:cNvSpPr/>
          <p:nvPr/>
        </p:nvSpPr>
        <p:spPr>
          <a:xfrm>
            <a:off x="763975" y="2018035"/>
            <a:ext cx="388753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l Table 1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Strains and Primers from EPIC mediate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ERG3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ERG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Transformation</a:t>
            </a:r>
            <a:endParaRPr lang="en-US" sz="3200" dirty="0"/>
          </a:p>
        </p:txBody>
      </p:sp>
    </p:spTree>
    <p:extLst>
      <p:ext uri="{BB962C8B-B14F-4D97-AF65-F5344CB8AC3E}">
        <p14:creationId xmlns:p14="http://schemas.microsoft.com/office/powerpoint/2010/main" val="1861518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BD50FB-86C3-4320-AFA5-F40BB78FD6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. Table 1 Cont.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42D65D0-18F5-4C37-A994-D0C25BF742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8001771"/>
              </p:ext>
            </p:extLst>
          </p:nvPr>
        </p:nvGraphicFramePr>
        <p:xfrm>
          <a:off x="5904903" y="1276944"/>
          <a:ext cx="4946244" cy="4462740"/>
        </p:xfrm>
        <a:graphic>
          <a:graphicData uri="http://schemas.openxmlformats.org/drawingml/2006/table">
            <a:tbl>
              <a:tblPr firstRow="1" firstCol="1" bandRow="1"/>
              <a:tblGrid>
                <a:gridCol w="1437370">
                  <a:extLst>
                    <a:ext uri="{9D8B030D-6E8A-4147-A177-3AD203B41FA5}">
                      <a16:colId xmlns:a16="http://schemas.microsoft.com/office/drawing/2014/main" val="3964873557"/>
                    </a:ext>
                  </a:extLst>
                </a:gridCol>
                <a:gridCol w="1860126">
                  <a:extLst>
                    <a:ext uri="{9D8B030D-6E8A-4147-A177-3AD203B41FA5}">
                      <a16:colId xmlns:a16="http://schemas.microsoft.com/office/drawing/2014/main" val="3427151195"/>
                    </a:ext>
                  </a:extLst>
                </a:gridCol>
                <a:gridCol w="1648748">
                  <a:extLst>
                    <a:ext uri="{9D8B030D-6E8A-4147-A177-3AD203B41FA5}">
                      <a16:colId xmlns:a16="http://schemas.microsoft.com/office/drawing/2014/main" val="2649945516"/>
                    </a:ext>
                  </a:extLst>
                </a:gridCol>
              </a:tblGrid>
              <a:tr h="28183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0113304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 bottom guide sequenc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aCGTAAACTTCGTCTTTTCT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ottom guide sequence inserted into pJMR19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3897739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 top guide sequenc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cGAGAAAAGACGAAGTTTAC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p guide sequence inserted into pJMR19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1364283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_AMP-F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CTGGAGCCTCCTCTAC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Block PCR amplification 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481084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_AMP-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ATGGGGTAGAGGTGGTAA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Block PCR amplification 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1367404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_Screening_AMP_F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AGTCGGACGATGCTC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ansformation screening 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6785258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_Screening_AMP_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CGTGGATCATGACGGTC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ansformation screening 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602354"/>
                  </a:ext>
                </a:extLst>
              </a:tr>
              <a:tr h="17614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3_Sequencin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CCAAGGATGGAGCA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nger Sequencing 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4055940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 bottom guide sequenc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cTCTTTTACTaGACTTTGCC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ottom guide sequence inserted into pJMR19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6442680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 top guide sequenc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aAGGCAAAGTCtAGTAAAAGA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p guide sequence inserted into pJMR19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1883230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_AMP-F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CATTCGTTCATAAACGAG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Block PCR amplification 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8182755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_AMP-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ACTGCTTCAAAGCGGTAG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Block PCR amplification 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2216880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_Screening_AMP_F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TTCACAGATCGGACGC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ansformation screening 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4622758"/>
                  </a:ext>
                </a:extLst>
              </a:tr>
              <a:tr h="30878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_Screening_AMP_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TAAAGCCAGTGAGCGTAGA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ansformation screening prime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295802"/>
                  </a:ext>
                </a:extLst>
              </a:tr>
              <a:tr h="1878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rg4_Sequencin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AGAGCTGGGAGAGC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nger Sequencing Primer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413" marR="6341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02764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065258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397446-4CC7-4BD3-B8C2-655CE0595E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. Table 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6EA6AFA-1E0A-4D79-AC97-8C27996D9550}"/>
              </a:ext>
            </a:extLst>
          </p:cNvPr>
          <p:cNvSpPr txBox="1"/>
          <p:nvPr/>
        </p:nvSpPr>
        <p:spPr>
          <a:xfrm>
            <a:off x="1441969" y="2957884"/>
            <a:ext cx="94312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rowth Curve Assay Across 190 Carbon Sources in LNV001 and LNV002.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is in excel document.</a:t>
            </a:r>
          </a:p>
        </p:txBody>
      </p:sp>
    </p:spTree>
    <p:extLst>
      <p:ext uri="{BB962C8B-B14F-4D97-AF65-F5344CB8AC3E}">
        <p14:creationId xmlns:p14="http://schemas.microsoft.com/office/powerpoint/2010/main" val="656038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b1dcc63b-7515-4abe-996a-38508cd47a62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A8A96A6B0333045878D03BAF6397942" ma:contentTypeVersion="18" ma:contentTypeDescription="Create a new document." ma:contentTypeScope="" ma:versionID="ac74762bdbc867285d9bb1a30ddb4c10">
  <xsd:schema xmlns:xsd="http://www.w3.org/2001/XMLSchema" xmlns:xs="http://www.w3.org/2001/XMLSchema" xmlns:p="http://schemas.microsoft.com/office/2006/metadata/properties" xmlns:ns3="b1dcc63b-7515-4abe-996a-38508cd47a62" xmlns:ns4="1e846a91-ccaa-466a-9a23-684f1ea5bcab" targetNamespace="http://schemas.microsoft.com/office/2006/metadata/properties" ma:root="true" ma:fieldsID="4d79e05a792f55d5dd984b473d34ee51" ns3:_="" ns4:_="">
    <xsd:import namespace="b1dcc63b-7515-4abe-996a-38508cd47a62"/>
    <xsd:import namespace="1e846a91-ccaa-466a-9a23-684f1ea5bca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_activity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ObjectDetectorVersions" minOccurs="0"/>
                <xsd:element ref="ns3:MediaServiceLocation" minOccurs="0"/>
                <xsd:element ref="ns3:MediaServiceSystemTags" minOccurs="0"/>
                <xsd:element ref="ns3:MediaLengthInSecond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1dcc63b-7515-4abe-996a-38508cd47a6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_activity" ma:index="17" nillable="true" ma:displayName="_activity" ma:hidden="true" ma:internalName="_activity">
      <xsd:simpleType>
        <xsd:restriction base="dms:Note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LengthInSeconds" ma:index="2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846a91-ccaa-466a-9a23-684f1ea5bcab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02D6188-2F0E-4FE3-9392-AFBEE4906682}">
  <ds:schemaRefs>
    <ds:schemaRef ds:uri="http://schemas.microsoft.com/office/2006/metadata/properties"/>
    <ds:schemaRef ds:uri="http://purl.org/dc/terms/"/>
    <ds:schemaRef ds:uri="1e846a91-ccaa-466a-9a23-684f1ea5bcab"/>
    <ds:schemaRef ds:uri="http://schemas.microsoft.com/office/2006/documentManagement/types"/>
    <ds:schemaRef ds:uri="http://schemas.microsoft.com/office/infopath/2007/PartnerControls"/>
    <ds:schemaRef ds:uri="b1dcc63b-7515-4abe-996a-38508cd47a62"/>
    <ds:schemaRef ds:uri="http://purl.org/dc/elements/1.1/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F9C08E10-5BD4-49B0-9A0D-82699E54D5E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1dcc63b-7515-4abe-996a-38508cd47a62"/>
    <ds:schemaRef ds:uri="1e846a91-ccaa-466a-9a23-684f1ea5bca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C01ACFB-BB5B-447C-9207-E7A775359A0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82</TotalTime>
  <Words>322</Words>
  <Application>Microsoft Office PowerPoint</Application>
  <PresentationFormat>Widescreen</PresentationFormat>
  <Paragraphs>89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ISIS/Draw Sketch</vt:lpstr>
      <vt:lpstr>Supplemental Figure 1</vt:lpstr>
      <vt:lpstr>Supp. Table 1</vt:lpstr>
      <vt:lpstr>Supp. Table 1 Cont.</vt:lpstr>
      <vt:lpstr>Supp. Table 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mB ERG3 Paper Figures and Tables</dc:title>
  <dc:creator>Lauryn Massic</dc:creator>
  <cp:lastModifiedBy>Lauryn Massic</cp:lastModifiedBy>
  <cp:revision>8</cp:revision>
  <dcterms:created xsi:type="dcterms:W3CDTF">2025-02-14T17:17:31Z</dcterms:created>
  <dcterms:modified xsi:type="dcterms:W3CDTF">2025-03-10T16:03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A8A96A6B0333045878D03BAF6397942</vt:lpwstr>
  </property>
</Properties>
</file>